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1042" r:id="rId2"/>
    <p:sldId id="104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2105" autoAdjust="0"/>
  </p:normalViewPr>
  <p:slideViewPr>
    <p:cSldViewPr snapToGrid="0">
      <p:cViewPr varScale="1">
        <p:scale>
          <a:sx n="88" d="100"/>
          <a:sy n="88" d="100"/>
        </p:scale>
        <p:origin x="135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0E201D-5DF6-4474-ACD5-F7DC28812641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40AAE7-175B-4CE6-86A6-E26D2A937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83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US" b="1" dirty="0"/>
              <a:t>Supplementary Figure S1. </a:t>
            </a:r>
            <a:r>
              <a:rPr lang="en-US" b="0" dirty="0"/>
              <a:t>(</a:t>
            </a:r>
            <a:r>
              <a:rPr lang="en-US" b="1" dirty="0"/>
              <a:t>A</a:t>
            </a:r>
            <a:r>
              <a:rPr lang="en-US" b="0" dirty="0"/>
              <a:t>)</a:t>
            </a:r>
            <a:r>
              <a:rPr lang="en-US" dirty="0"/>
              <a:t> Box plots of selected urine metabolites showing radiation dose rate/type differences at Day 30 post-irradiation. Each box plot represents normalized intensity values across four treatment groups: Control, PBI-BM2.5, WBI-LDR, and WBI-HDR, highlighting group-specific metabolite intensity patterns. (</a:t>
            </a:r>
            <a:r>
              <a:rPr lang="en-US" b="1" dirty="0"/>
              <a:t>B</a:t>
            </a:r>
            <a:r>
              <a:rPr lang="en-US" b="0" dirty="0"/>
              <a:t>)</a:t>
            </a:r>
            <a:r>
              <a:rPr lang="en-US" dirty="0"/>
              <a:t> Heat map of selected urine metabolites showing radiation dose rate/type differences across Days 2 and 30. Each row represents a metabolite, with color intensity reflecting normalized metabolite levels. Warmer colors (red) indicate higher levels, while cooler colors (blue) represent lower levels, illustrating temporal and dose-specific variations in metabolite profile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01FC30-4008-F94A-8688-B3F0336182C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6541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S2. </a:t>
            </a:r>
            <a:r>
              <a:rPr lang="en-US" dirty="0"/>
              <a:t>Evaluation of prediction models for multi-class outcomes using neural network (N-net) algorithm. (</a:t>
            </a:r>
            <a:r>
              <a:rPr lang="en-US" b="1" dirty="0"/>
              <a:t>A</a:t>
            </a:r>
            <a:r>
              <a:rPr lang="en-US" dirty="0"/>
              <a:t>,</a:t>
            </a:r>
            <a:r>
              <a:rPr lang="en-US" b="1" dirty="0"/>
              <a:t>B</a:t>
            </a:r>
            <a:r>
              <a:rPr lang="en-US" dirty="0"/>
              <a:t>) Multi-class confusion matrix for Day 2 and Day 30 using the N-Net model. (</a:t>
            </a:r>
            <a:r>
              <a:rPr lang="en-US" b="1" dirty="0"/>
              <a:t>C</a:t>
            </a:r>
            <a:r>
              <a:rPr lang="en-US" dirty="0"/>
              <a:t>,</a:t>
            </a:r>
            <a:r>
              <a:rPr lang="en-US" b="1" dirty="0"/>
              <a:t>D</a:t>
            </a:r>
            <a:r>
              <a:rPr lang="en-US" dirty="0"/>
              <a:t>) Performance metrics for classification models using N-Net model at Day 2 and Day 30 </a:t>
            </a:r>
            <a:r>
              <a:rPr lang="en-US"/>
              <a:t>respectively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40AAE7-175B-4CE6-86A6-E26D2A937CD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1989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154955-8076-4628-85E0-1D9866D830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AD87E08-ABAA-4366-AF3E-38FD4EC96E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79E5FB-8479-46A3-806D-2EF0835E8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1E703B-ED5C-4701-B30D-DC11770B4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3018B3-316F-4CA9-8853-8C937C824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265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1E9BE6-A317-4855-BC78-93A2FFC43D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AE5659-A5C2-473E-9923-6129D30E16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6AB503-BAD2-4334-B919-915FE8A4F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7516CC-729A-4538-A91D-20EC2D998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040D59-B188-44F2-B95B-72FFA5B1B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153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470414-9A85-4F7C-B1A9-2B2FB36B1F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57E0E0-5C7A-409B-9330-CC9832BBFD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0BF735-63B9-41B6-8A4E-79272B2B85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EE2F9D-E40C-45A9-BC41-389461B82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42FBC6-CE4C-4A70-AA35-70B9900AF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035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CDE428-DB02-4197-BC2F-3958BA2A58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22F3F5-DD94-4926-A31F-50BA5AF114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FBA1B8-8295-44AA-929B-0F6D73BFE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918A9F-2512-49E4-BE86-6B27ABA98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6176F-6F4F-464A-97C4-109F08ECD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325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F2ED69-0614-44D8-8585-D04623685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E1AE72-FBEF-49AE-9327-A3FF266C83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340989-FCFD-46BE-802C-4B8EA8603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8815C8-BB87-4116-A129-E89C7371D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CCACD6-06A6-4C19-B74C-AC96D3EC2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850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86AEEC-9243-4C8D-BFD8-C4036B326E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201171-3F70-4375-B64A-0610365057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8C5D1D-F449-4F16-86D1-FE7A6FF16D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F9BC5F-A2F2-41C2-BDA7-38FB79953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F15A7A-08EF-4A2C-8584-887173586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23DB33-E4F3-4F5E-9EE7-F2162BA30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53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6A774F-974D-4C2A-83FD-7A43320537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56F4A4-7291-40A1-BFEF-939BB73D81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28E1D3-2974-49BD-8B35-E9C9492792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086948-7929-4FC3-A242-8E947F97F1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A9D464-8E70-4389-8C71-EA60D60E88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0D9C73-1043-4036-A3A3-A8A9615E7F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17F407B-959F-4F5F-BE9D-400A2CC2D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5EB5E8-0530-4A0F-BD3E-836E7B52F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85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DAC543-CFEB-4C41-B169-4A54AC23AD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3C4C34-FA7A-4C51-8401-F9AB42BF4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00789AD-3C14-4E1B-AD38-3465026285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42DD6F-6346-4A15-B5DD-7A64D5496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14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429CEF-6EC8-4119-9A74-0F2DF3346C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F063FE-5DFF-4A90-B547-FEE203C2F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BC5458C-515C-4469-A831-240F33902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265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1242A4-A88F-41DB-AF79-E07448D581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7C558E-3784-4DCA-85D5-A2595CDF4A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FE37B2-CD46-4909-9588-101792D36F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EF3E1B-F524-4F23-A39D-3A0EE9C37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1DE1F0-FDCA-45D4-9167-C8888606A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A09241-9005-498F-B8F4-7B75265B7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296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34640C-8443-444D-A8AE-231226D3EE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771D316-F0C6-47EE-B703-22700D02AA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C8777C-0DA2-4C40-9D8E-C4E4400636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6F609D-5E34-41E9-B503-DB98A0759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E266F7-BABF-4321-A31A-DF747D5B4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59742A-4937-4DAC-9F39-E456FF58F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102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FCAA1E-E591-4E6B-B931-43C72BB4F0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258F7F-CDAE-43F7-8D9A-56EB9D9EC3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594B03-3816-40DA-8109-B4F5E33B14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5E3B6F-B792-4B4C-8E6F-59D3278F5C5C}" type="datetimeFigureOut">
              <a:rPr lang="en-US" smtClean="0"/>
              <a:t>2024-12-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C99530-06F4-4833-9C45-D691DF9803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1E72A1-D11A-450C-B7AD-BE77603E48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36C4B2-C4D1-4B07-9F57-DBBC5C9E7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17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tiff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id="{001077CD-7F70-40C5-A9A3-01D9E95051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652" y="257175"/>
            <a:ext cx="2743200" cy="22860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5740464-BA86-4E0C-AD7B-B2F88EA5DC2E}"/>
              </a:ext>
            </a:extLst>
          </p:cNvPr>
          <p:cNvSpPr txBox="1"/>
          <p:nvPr/>
        </p:nvSpPr>
        <p:spPr>
          <a:xfrm>
            <a:off x="1132455" y="257175"/>
            <a:ext cx="13995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DHAP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F7574E39-2379-4D6E-94DA-2F2ACA84577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86826" y="257175"/>
            <a:ext cx="2743200" cy="2286000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EE8FD81A-5914-4E98-B692-72C276C17CB2}"/>
              </a:ext>
            </a:extLst>
          </p:cNvPr>
          <p:cNvSpPr txBox="1"/>
          <p:nvPr/>
        </p:nvSpPr>
        <p:spPr>
          <a:xfrm>
            <a:off x="3756451" y="257175"/>
            <a:ext cx="139951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2-Deoxyglucose-6-Phosphate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B6671FBC-9693-4B82-964C-452C2A71149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257175"/>
            <a:ext cx="2743200" cy="228600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434DBD44-A1C1-4921-A6BE-E9ABC849F898}"/>
              </a:ext>
            </a:extLst>
          </p:cNvPr>
          <p:cNvSpPr txBox="1"/>
          <p:nvPr/>
        </p:nvSpPr>
        <p:spPr>
          <a:xfrm>
            <a:off x="6844426" y="257175"/>
            <a:ext cx="13995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 err="1"/>
              <a:t>Adenylosuccinate</a:t>
            </a:r>
            <a:endParaRPr lang="en-US" sz="1200" b="1" dirty="0"/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ABA189D5-4902-49C4-843A-1A1FDF0491A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05174" y="257175"/>
            <a:ext cx="2743200" cy="228600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5888188C-1FCF-4FBA-B382-9018BCDCD45F}"/>
              </a:ext>
            </a:extLst>
          </p:cNvPr>
          <p:cNvSpPr txBox="1"/>
          <p:nvPr/>
        </p:nvSpPr>
        <p:spPr>
          <a:xfrm>
            <a:off x="9871286" y="257175"/>
            <a:ext cx="14878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 err="1"/>
              <a:t>Carbamoylaspartate</a:t>
            </a:r>
            <a:endParaRPr lang="en-US" sz="1200" b="1" dirty="0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E34EF691-44B4-4ACB-8B5B-524BB34CFC6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7652" y="2543175"/>
            <a:ext cx="2743200" cy="2286000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2790361E-6019-4E5D-8AE7-1BE220B8E320}"/>
              </a:ext>
            </a:extLst>
          </p:cNvPr>
          <p:cNvSpPr txBox="1"/>
          <p:nvPr/>
        </p:nvSpPr>
        <p:spPr>
          <a:xfrm>
            <a:off x="871864" y="2491968"/>
            <a:ext cx="151207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Phenyllactate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EB05EF24-473A-4CC8-AAEF-9C68FEE7702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86826" y="2543175"/>
            <a:ext cx="2743200" cy="2286000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F8B46422-A393-40E7-BBEE-674E4C0A9678}"/>
              </a:ext>
            </a:extLst>
          </p:cNvPr>
          <p:cNvSpPr txBox="1"/>
          <p:nvPr/>
        </p:nvSpPr>
        <p:spPr>
          <a:xfrm>
            <a:off x="3902578" y="2491968"/>
            <a:ext cx="22015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 err="1"/>
              <a:t>Ureidosuccinic</a:t>
            </a:r>
            <a:r>
              <a:rPr lang="en-US" sz="1200" b="1" dirty="0"/>
              <a:t> Acid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B332B32D-B798-437E-B19A-503CD1E5E83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96000" y="2543175"/>
            <a:ext cx="2743200" cy="22860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53607C38-B77C-49B0-89DB-D48E9B20C20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005174" y="2543175"/>
            <a:ext cx="2743200" cy="2286000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AB1970A6-D00B-4A61-BC83-54ADEAEB7F78}"/>
              </a:ext>
            </a:extLst>
          </p:cNvPr>
          <p:cNvSpPr txBox="1"/>
          <p:nvPr/>
        </p:nvSpPr>
        <p:spPr>
          <a:xfrm>
            <a:off x="7239275" y="2491968"/>
            <a:ext cx="188888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 err="1"/>
              <a:t>Succinylcarnitine</a:t>
            </a:r>
            <a:endParaRPr lang="en-US" sz="1200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AB07225-FD1D-4EB9-B4E3-97803B8D9B76}"/>
              </a:ext>
            </a:extLst>
          </p:cNvPr>
          <p:cNvSpPr txBox="1"/>
          <p:nvPr/>
        </p:nvSpPr>
        <p:spPr>
          <a:xfrm>
            <a:off x="9871286" y="2491968"/>
            <a:ext cx="188888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 err="1"/>
              <a:t>Indolepropionate</a:t>
            </a:r>
            <a:endParaRPr lang="en-US" sz="1200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D27EC5D-E8F4-4870-AFC2-F4BBC47B1755}"/>
              </a:ext>
            </a:extLst>
          </p:cNvPr>
          <p:cNvSpPr txBox="1"/>
          <p:nvPr/>
        </p:nvSpPr>
        <p:spPr>
          <a:xfrm>
            <a:off x="443626" y="165060"/>
            <a:ext cx="13995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Day 30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88D92FD8-1E10-47AC-875B-06249C20EC70}"/>
              </a:ext>
            </a:extLst>
          </p:cNvPr>
          <p:cNvGrpSpPr/>
          <p:nvPr/>
        </p:nvGrpSpPr>
        <p:grpSpPr>
          <a:xfrm>
            <a:off x="178703" y="4777968"/>
            <a:ext cx="11868150" cy="1993998"/>
            <a:chOff x="161925" y="4723413"/>
            <a:chExt cx="11868150" cy="1993998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0CFEDD6-5815-4370-B030-C525B849534D}"/>
                </a:ext>
              </a:extLst>
            </p:cNvPr>
            <p:cNvSpPr txBox="1"/>
            <p:nvPr/>
          </p:nvSpPr>
          <p:spPr>
            <a:xfrm>
              <a:off x="616250" y="4723413"/>
              <a:ext cx="5950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Day 2</a:t>
              </a:r>
            </a:p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Control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2247BC8-BEFD-4316-81C2-463441600672}"/>
                </a:ext>
              </a:extLst>
            </p:cNvPr>
            <p:cNvSpPr txBox="1"/>
            <p:nvPr/>
          </p:nvSpPr>
          <p:spPr>
            <a:xfrm>
              <a:off x="1845799" y="4723413"/>
              <a:ext cx="7489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Day 2</a:t>
              </a:r>
            </a:p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PBI BM2.5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89BD00D-9F69-4B1C-8BCD-BEE9EDB50AFA}"/>
                </a:ext>
              </a:extLst>
            </p:cNvPr>
            <p:cNvSpPr txBox="1"/>
            <p:nvPr/>
          </p:nvSpPr>
          <p:spPr>
            <a:xfrm>
              <a:off x="3074864" y="4723413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Day 2</a:t>
              </a:r>
            </a:p>
            <a:p>
              <a:pPr algn="ctr"/>
              <a:r>
                <a:rPr lang="en-US" sz="900" b="1" i="0" u="none" strike="noStrike" dirty="0">
                  <a:solidFill>
                    <a:srgbClr val="000000"/>
                  </a:solidFill>
                  <a:effectLst/>
                  <a:latin typeface="Helvectica"/>
                  <a:cs typeface="Times New Roman" panose="02020603050405020304" pitchFamily="18" charset="0"/>
                </a:rPr>
                <a:t>WBI LDR</a:t>
              </a:r>
              <a:endParaRPr lang="en-US" sz="900" b="1" dirty="0">
                <a:latin typeface="Helvectica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FEF9746-E143-4E4F-B792-AD26E068B4F3}"/>
                </a:ext>
              </a:extLst>
            </p:cNvPr>
            <p:cNvSpPr txBox="1"/>
            <p:nvPr/>
          </p:nvSpPr>
          <p:spPr>
            <a:xfrm>
              <a:off x="4321337" y="4723413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Day 2</a:t>
              </a:r>
            </a:p>
            <a:p>
              <a:pPr algn="ctr"/>
              <a:r>
                <a:rPr lang="en-US" sz="900" b="1" i="0" u="none" strike="noStrike" dirty="0">
                  <a:solidFill>
                    <a:srgbClr val="000000"/>
                  </a:solidFill>
                  <a:effectLst/>
                  <a:latin typeface="Helvectica"/>
                  <a:cs typeface="Times New Roman" panose="02020603050405020304" pitchFamily="18" charset="0"/>
                </a:rPr>
                <a:t>WBI </a:t>
              </a:r>
              <a:r>
                <a:rPr lang="en-US" sz="900" b="1" dirty="0">
                  <a:solidFill>
                    <a:srgbClr val="000000"/>
                  </a:solidFill>
                  <a:latin typeface="Helvectica"/>
                  <a:cs typeface="Times New Roman" panose="02020603050405020304" pitchFamily="18" charset="0"/>
                </a:rPr>
                <a:t>H</a:t>
              </a:r>
              <a:r>
                <a:rPr lang="en-US" sz="900" b="1" i="0" u="none" strike="noStrike" dirty="0">
                  <a:solidFill>
                    <a:srgbClr val="000000"/>
                  </a:solidFill>
                  <a:effectLst/>
                  <a:latin typeface="Helvectica"/>
                  <a:cs typeface="Times New Roman" panose="02020603050405020304" pitchFamily="18" charset="0"/>
                </a:rPr>
                <a:t>DR</a:t>
              </a:r>
              <a:endParaRPr lang="en-US" sz="900" b="1" dirty="0">
                <a:latin typeface="Helvectica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B61D92D-0563-4B3D-8F73-960AFF4BEB44}"/>
                </a:ext>
              </a:extLst>
            </p:cNvPr>
            <p:cNvSpPr txBox="1"/>
            <p:nvPr/>
          </p:nvSpPr>
          <p:spPr>
            <a:xfrm>
              <a:off x="5744670" y="4723413"/>
              <a:ext cx="5950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Day 30</a:t>
              </a:r>
            </a:p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Control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E82BC27-2F0A-4FE2-9B9B-E3F05F845EF9}"/>
                </a:ext>
              </a:extLst>
            </p:cNvPr>
            <p:cNvSpPr txBox="1"/>
            <p:nvPr/>
          </p:nvSpPr>
          <p:spPr>
            <a:xfrm>
              <a:off x="7050982" y="4723413"/>
              <a:ext cx="7489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Day 30</a:t>
              </a:r>
            </a:p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PBI BM2.5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64853DE-B19B-429C-B35D-367246612DE1}"/>
                </a:ext>
              </a:extLst>
            </p:cNvPr>
            <p:cNvSpPr txBox="1"/>
            <p:nvPr/>
          </p:nvSpPr>
          <p:spPr>
            <a:xfrm>
              <a:off x="8272010" y="4723413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Day 30</a:t>
              </a:r>
            </a:p>
            <a:p>
              <a:pPr algn="ctr"/>
              <a:r>
                <a:rPr lang="en-US" sz="900" b="1" i="0" u="none" strike="noStrike" dirty="0">
                  <a:solidFill>
                    <a:srgbClr val="000000"/>
                  </a:solidFill>
                  <a:effectLst/>
                  <a:latin typeface="Helvectica"/>
                  <a:cs typeface="Times New Roman" panose="02020603050405020304" pitchFamily="18" charset="0"/>
                </a:rPr>
                <a:t>WBI LDR</a:t>
              </a:r>
              <a:endParaRPr lang="en-US" sz="900" b="1" dirty="0">
                <a:latin typeface="Helvectica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9C348C4-9916-4DA5-BC10-5D20C74B0D4C}"/>
                </a:ext>
              </a:extLst>
            </p:cNvPr>
            <p:cNvSpPr txBox="1"/>
            <p:nvPr/>
          </p:nvSpPr>
          <p:spPr>
            <a:xfrm>
              <a:off x="9516901" y="4723413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Helvectica"/>
                  <a:cs typeface="Times New Roman" panose="02020603050405020304" pitchFamily="18" charset="0"/>
                </a:rPr>
                <a:t>Day 30</a:t>
              </a:r>
            </a:p>
            <a:p>
              <a:pPr algn="ctr"/>
              <a:r>
                <a:rPr lang="en-US" sz="900" b="1" i="0" u="none" strike="noStrike" dirty="0">
                  <a:solidFill>
                    <a:srgbClr val="000000"/>
                  </a:solidFill>
                  <a:effectLst/>
                  <a:latin typeface="Helvectica"/>
                  <a:cs typeface="Times New Roman" panose="02020603050405020304" pitchFamily="18" charset="0"/>
                </a:rPr>
                <a:t>WBI </a:t>
              </a:r>
              <a:r>
                <a:rPr lang="en-US" sz="900" b="1" dirty="0">
                  <a:solidFill>
                    <a:srgbClr val="000000"/>
                  </a:solidFill>
                  <a:latin typeface="Helvectica"/>
                  <a:cs typeface="Times New Roman" panose="02020603050405020304" pitchFamily="18" charset="0"/>
                </a:rPr>
                <a:t>H</a:t>
              </a:r>
              <a:r>
                <a:rPr lang="en-US" sz="900" b="1" i="0" u="none" strike="noStrike" dirty="0">
                  <a:solidFill>
                    <a:srgbClr val="000000"/>
                  </a:solidFill>
                  <a:effectLst/>
                  <a:latin typeface="Helvectica"/>
                  <a:cs typeface="Times New Roman" panose="02020603050405020304" pitchFamily="18" charset="0"/>
                </a:rPr>
                <a:t>DR</a:t>
              </a:r>
              <a:endParaRPr lang="en-US" sz="900" b="1" dirty="0">
                <a:latin typeface="Helvectica"/>
                <a:cs typeface="Times New Roman" panose="02020603050405020304" pitchFamily="18" charset="0"/>
              </a:endParaRPr>
            </a:p>
          </p:txBody>
        </p:sp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203CFDBE-1862-4ACF-9722-5E1E0C982D7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1925" y="5055870"/>
              <a:ext cx="11868150" cy="1661541"/>
            </a:xfrm>
            <a:prstGeom prst="rect">
              <a:avLst/>
            </a:prstGeom>
          </p:spPr>
        </p:pic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3520A7E5-AFDE-4265-8FD2-57C15B1A6FB6}"/>
              </a:ext>
            </a:extLst>
          </p:cNvPr>
          <p:cNvSpPr txBox="1"/>
          <p:nvPr/>
        </p:nvSpPr>
        <p:spPr>
          <a:xfrm>
            <a:off x="178703" y="461486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Helvectica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CAB6D80-0AA3-4C47-9043-500A933D3225}"/>
              </a:ext>
            </a:extLst>
          </p:cNvPr>
          <p:cNvSpPr txBox="1"/>
          <p:nvPr/>
        </p:nvSpPr>
        <p:spPr>
          <a:xfrm>
            <a:off x="178704" y="5733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Helvectica"/>
                <a:cs typeface="Times New Roman" panose="02020603050405020304" pitchFamily="18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237691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6746F9E-5263-4202-BE0C-6C6CC7098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5674170"/>
              </p:ext>
            </p:extLst>
          </p:nvPr>
        </p:nvGraphicFramePr>
        <p:xfrm>
          <a:off x="2084228" y="3073360"/>
          <a:ext cx="8002512" cy="1152843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649289">
                  <a:extLst>
                    <a:ext uri="{9D8B030D-6E8A-4147-A177-3AD203B41FA5}">
                      <a16:colId xmlns:a16="http://schemas.microsoft.com/office/drawing/2014/main" val="2508680907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758586854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385669824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651472469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938134609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603955919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490307041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319893941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750176767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917393457"/>
                    </a:ext>
                  </a:extLst>
                </a:gridCol>
                <a:gridCol w="769543">
                  <a:extLst>
                    <a:ext uri="{9D8B030D-6E8A-4147-A177-3AD203B41FA5}">
                      <a16:colId xmlns:a16="http://schemas.microsoft.com/office/drawing/2014/main" val="4022573163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Class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Sensitivity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Specificity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PPV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NPV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Prevalence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Recall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F1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Prevalence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Balanced Accuracy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Model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333466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-Ne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921115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BI.BM2.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-Ne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223324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WBI.HD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-Ne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142835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WBI.LD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-Ne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2753494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297D27D6-A547-4C63-A9AB-5BD848C0136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4650948"/>
              </p:ext>
            </p:extLst>
          </p:nvPr>
        </p:nvGraphicFramePr>
        <p:xfrm>
          <a:off x="2084227" y="4366620"/>
          <a:ext cx="8021218" cy="1152843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649289">
                  <a:extLst>
                    <a:ext uri="{9D8B030D-6E8A-4147-A177-3AD203B41FA5}">
                      <a16:colId xmlns:a16="http://schemas.microsoft.com/office/drawing/2014/main" val="3702978064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4150892305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40776305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719049176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4088244366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707074305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7529791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247503938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843728313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911804712"/>
                    </a:ext>
                  </a:extLst>
                </a:gridCol>
                <a:gridCol w="788249">
                  <a:extLst>
                    <a:ext uri="{9D8B030D-6E8A-4147-A177-3AD203B41FA5}">
                      <a16:colId xmlns:a16="http://schemas.microsoft.com/office/drawing/2014/main" val="137254313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Class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Sensitivity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Specificity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PPV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NPV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Precision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Recall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F1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Prevalence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Balanced Accuracy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Model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22574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-Ne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762428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BI.BM2.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-Ne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976374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WBI.HD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-Ne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484664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WBI.LD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-Ne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7394509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80FD70A5-1385-4C73-9677-B3C1EB708D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9141819"/>
              </p:ext>
            </p:extLst>
          </p:nvPr>
        </p:nvGraphicFramePr>
        <p:xfrm>
          <a:off x="2084227" y="1839369"/>
          <a:ext cx="3657600" cy="108585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870191">
                  <a:extLst>
                    <a:ext uri="{9D8B030D-6E8A-4147-A177-3AD203B41FA5}">
                      <a16:colId xmlns:a16="http://schemas.microsoft.com/office/drawing/2014/main" val="638374437"/>
                    </a:ext>
                  </a:extLst>
                </a:gridCol>
                <a:gridCol w="640809">
                  <a:extLst>
                    <a:ext uri="{9D8B030D-6E8A-4147-A177-3AD203B41FA5}">
                      <a16:colId xmlns:a16="http://schemas.microsoft.com/office/drawing/2014/main" val="1556078604"/>
                    </a:ext>
                  </a:extLst>
                </a:gridCol>
                <a:gridCol w="798007">
                  <a:extLst>
                    <a:ext uri="{9D8B030D-6E8A-4147-A177-3AD203B41FA5}">
                      <a16:colId xmlns:a16="http://schemas.microsoft.com/office/drawing/2014/main" val="3155372831"/>
                    </a:ext>
                  </a:extLst>
                </a:gridCol>
                <a:gridCol w="707784">
                  <a:extLst>
                    <a:ext uri="{9D8B030D-6E8A-4147-A177-3AD203B41FA5}">
                      <a16:colId xmlns:a16="http://schemas.microsoft.com/office/drawing/2014/main" val="1134646670"/>
                    </a:ext>
                  </a:extLst>
                </a:gridCol>
                <a:gridCol w="640809">
                  <a:extLst>
                    <a:ext uri="{9D8B030D-6E8A-4147-A177-3AD203B41FA5}">
                      <a16:colId xmlns:a16="http://schemas.microsoft.com/office/drawing/2014/main" val="2553242399"/>
                    </a:ext>
                  </a:extLst>
                </a:gridCol>
              </a:tblGrid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Day 2 N-Net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Reference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7101698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Prediction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Control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PBI.BM2.5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WBI.HDR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WBI.LDR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830462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</a:rPr>
                        <a:t>Contro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5822442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</a:rPr>
                        <a:t>PBI.BM2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28421589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</a:rPr>
                        <a:t>WBI.HD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73694071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</a:rPr>
                        <a:t>WBI.LD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186995843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2F26A1A7-3B3C-4746-B58B-8474D6E396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90267824"/>
              </p:ext>
            </p:extLst>
          </p:nvPr>
        </p:nvGraphicFramePr>
        <p:xfrm>
          <a:off x="6416433" y="1839369"/>
          <a:ext cx="3657600" cy="108585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935332">
                  <a:extLst>
                    <a:ext uri="{9D8B030D-6E8A-4147-A177-3AD203B41FA5}">
                      <a16:colId xmlns:a16="http://schemas.microsoft.com/office/drawing/2014/main" val="1477078727"/>
                    </a:ext>
                  </a:extLst>
                </a:gridCol>
                <a:gridCol w="627904">
                  <a:extLst>
                    <a:ext uri="{9D8B030D-6E8A-4147-A177-3AD203B41FA5}">
                      <a16:colId xmlns:a16="http://schemas.microsoft.com/office/drawing/2014/main" val="1955566021"/>
                    </a:ext>
                  </a:extLst>
                </a:gridCol>
                <a:gridCol w="777166">
                  <a:extLst>
                    <a:ext uri="{9D8B030D-6E8A-4147-A177-3AD203B41FA5}">
                      <a16:colId xmlns:a16="http://schemas.microsoft.com/office/drawing/2014/main" val="3064777928"/>
                    </a:ext>
                  </a:extLst>
                </a:gridCol>
                <a:gridCol w="689294">
                  <a:extLst>
                    <a:ext uri="{9D8B030D-6E8A-4147-A177-3AD203B41FA5}">
                      <a16:colId xmlns:a16="http://schemas.microsoft.com/office/drawing/2014/main" val="4253151565"/>
                    </a:ext>
                  </a:extLst>
                </a:gridCol>
                <a:gridCol w="627904">
                  <a:extLst>
                    <a:ext uri="{9D8B030D-6E8A-4147-A177-3AD203B41FA5}">
                      <a16:colId xmlns:a16="http://schemas.microsoft.com/office/drawing/2014/main" val="2294931351"/>
                    </a:ext>
                  </a:extLst>
                </a:gridCol>
              </a:tblGrid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Day 30 N-Net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Reference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77161713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Prediction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PBI.BM2.5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solidFill>
                            <a:schemeClr val="bg1"/>
                          </a:solidFill>
                          <a:effectLst/>
                        </a:rPr>
                        <a:t>WBI.HDR</a:t>
                      </a:r>
                      <a:endParaRPr lang="en-US" sz="11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WBI.LDR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278637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77099379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BI.BM2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01034024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WBI.HD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93556126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WBI.LD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31289136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276B53E3-D91E-41D7-9F91-24501A687CF2}"/>
              </a:ext>
            </a:extLst>
          </p:cNvPr>
          <p:cNvSpPr txBox="1"/>
          <p:nvPr/>
        </p:nvSpPr>
        <p:spPr>
          <a:xfrm>
            <a:off x="1698470" y="170422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9256B87-7C6A-4D2A-A71F-8E789A442E33}"/>
              </a:ext>
            </a:extLst>
          </p:cNvPr>
          <p:cNvSpPr txBox="1"/>
          <p:nvPr/>
        </p:nvSpPr>
        <p:spPr>
          <a:xfrm>
            <a:off x="6057502" y="170422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FC9C336-9628-42E2-9ACD-9D05C06D0250}"/>
              </a:ext>
            </a:extLst>
          </p:cNvPr>
          <p:cNvSpPr txBox="1"/>
          <p:nvPr/>
        </p:nvSpPr>
        <p:spPr>
          <a:xfrm>
            <a:off x="1680838" y="295964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25AAF2-65D8-43BC-9021-A9FAF55BECEB}"/>
              </a:ext>
            </a:extLst>
          </p:cNvPr>
          <p:cNvSpPr txBox="1"/>
          <p:nvPr/>
        </p:nvSpPr>
        <p:spPr>
          <a:xfrm>
            <a:off x="1682440" y="426502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174867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</TotalTime>
  <Words>430</Words>
  <Application>Microsoft Office PowerPoint</Application>
  <PresentationFormat>Widescreen</PresentationFormat>
  <Paragraphs>199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Helvectica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oxiang Li</dc:creator>
  <cp:lastModifiedBy>MDPI</cp:lastModifiedBy>
  <cp:revision>25</cp:revision>
  <dcterms:created xsi:type="dcterms:W3CDTF">2024-07-19T19:21:33Z</dcterms:created>
  <dcterms:modified xsi:type="dcterms:W3CDTF">2024-12-24T13:34:24Z</dcterms:modified>
</cp:coreProperties>
</file>